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Chart, scatter chart">
            <a:extLst>
              <a:ext uri="{FF2B5EF4-FFF2-40B4-BE49-F238E27FC236}">
                <a16:creationId xmlns:a16="http://schemas.microsoft.com/office/drawing/2014/main" id="{50016DA8-A05B-26B6-2309-560F3D8336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2575" y="189000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264587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5: Figure 2S(a-c): Lumbar spine [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8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]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aF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PET/CT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andardised uptake values</a:t>
            </a:r>
          </a:p>
          <a:p>
            <a:pPr algn="just"/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T: Positron emission tomography, CT: computed tomography, SUV: standardised uptake value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316524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09873" y="3307405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4" name="Picture 3" descr="Chart, line chart&#10;&#10;Description automatically generated">
            <a:extLst>
              <a:ext uri="{FF2B5EF4-FFF2-40B4-BE49-F238E27FC236}">
                <a16:creationId xmlns:a16="http://schemas.microsoft.com/office/drawing/2014/main" id="{FF07812D-CDE0-127A-028C-009E8E96E28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190" y="3730687"/>
            <a:ext cx="4051935" cy="2948940"/>
          </a:xfrm>
          <a:prstGeom prst="rect">
            <a:avLst/>
          </a:prstGeom>
        </p:spPr>
      </p:pic>
      <p:pic>
        <p:nvPicPr>
          <p:cNvPr id="8" name="Picture 7" descr="Chart&#10;&#10;Description automatically generated">
            <a:extLst>
              <a:ext uri="{FF2B5EF4-FFF2-40B4-BE49-F238E27FC236}">
                <a16:creationId xmlns:a16="http://schemas.microsoft.com/office/drawing/2014/main" id="{77984F87-F370-F0E1-DC34-BA81F7A399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769" y="3730687"/>
            <a:ext cx="4051935" cy="2948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292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92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18:30Z</dcterms:modified>
</cp:coreProperties>
</file>